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670AE8-538B-4642-B082-D6DF59689D1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85F329-DE54-4D20-9097-E461EA18EB4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308771-E1E7-4742-96CA-91CA23A1602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C26195-CD35-497F-AD84-F7F754AC283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FAF862-E3AD-4DEB-8A58-5403433C713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F93333-205F-4283-AD53-1F5CA01323A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020126-3DF9-4CC4-9CD2-D56D10F82CE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AB3091-833B-4A8F-9C7D-78F2957AD92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537055-5150-4A01-980E-B46B90FAFFD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6B7F8C-947D-4144-A793-FC37F78F6F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150ECA-95A9-41D9-BFAE-7897274859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281F3A-C8D0-4141-B74B-FEFEA8BE24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3A24C9C-BA45-4732-9B14-B269C13F78E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82600" y="6161040"/>
            <a:ext cx="638640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RSPO1 immuno-detection on 50 d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pc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male mesonephros (a) and on female and male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Gonads (b)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Note the RSPO1 staining of different epithelial cells of the mesonephros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hose of  the coelomic epithelium (ce), of the Müllerian duct (m) and of mesonephotic duc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(md).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The dotted line delineates the tunica albuginea (ta) of the testis. Scale bars: 100µm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3978360" y="1666800"/>
            <a:ext cx="144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" name=""/>
          <p:cNvGrpSpPr/>
          <p:nvPr/>
        </p:nvGrpSpPr>
        <p:grpSpPr>
          <a:xfrm>
            <a:off x="1388880" y="1619280"/>
            <a:ext cx="3592800" cy="3730680"/>
            <a:chOff x="1388880" y="1619280"/>
            <a:chExt cx="3592800" cy="3730680"/>
          </a:xfrm>
        </p:grpSpPr>
        <p:sp>
          <p:nvSpPr>
            <p:cNvPr id="44" name=""/>
            <p:cNvSpPr/>
            <p:nvPr/>
          </p:nvSpPr>
          <p:spPr>
            <a:xfrm>
              <a:off x="1401480" y="1619280"/>
              <a:ext cx="316800" cy="392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87120" rIns="87120" tIns="43560" bIns="43560" anchor="t">
              <a:spAutoFit/>
            </a:bodyPr>
            <a:p>
              <a:pPr>
                <a:tabLst>
                  <a:tab algn="l" pos="0"/>
                  <a:tab algn="l" pos="873000"/>
                  <a:tab algn="l" pos="1746360"/>
                  <a:tab algn="l" pos="2619360"/>
                  <a:tab algn="l" pos="3492360"/>
                  <a:tab algn="l" pos="4365720"/>
                  <a:tab algn="l" pos="5238720"/>
                  <a:tab algn="l" pos="6111720"/>
                  <a:tab algn="l" pos="6985080"/>
                  <a:tab algn="l" pos="7858080"/>
                  <a:tab algn="l" pos="8731080"/>
                  <a:tab algn="l" pos="9604440"/>
                  <a:tab algn="l" pos="10477440"/>
                </a:tabLst>
              </a:pPr>
              <a:r>
                <a:rPr b="0" i="1" lang="en-US" sz="20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1388880" y="3710160"/>
              <a:ext cx="316800" cy="392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87120" rIns="87120" tIns="43560" bIns="43560" anchor="t">
              <a:spAutoFit/>
            </a:bodyPr>
            <a:p>
              <a:pPr>
                <a:tabLst>
                  <a:tab algn="l" pos="0"/>
                  <a:tab algn="l" pos="873000"/>
                  <a:tab algn="l" pos="1746360"/>
                  <a:tab algn="l" pos="2619360"/>
                  <a:tab algn="l" pos="3492360"/>
                  <a:tab algn="l" pos="4365720"/>
                  <a:tab algn="l" pos="5238720"/>
                  <a:tab algn="l" pos="6111720"/>
                  <a:tab algn="l" pos="6985080"/>
                  <a:tab algn="l" pos="7858080"/>
                  <a:tab algn="l" pos="8731080"/>
                  <a:tab algn="l" pos="9604440"/>
                  <a:tab algn="l" pos="10477440"/>
                </a:tabLst>
              </a:pPr>
              <a:r>
                <a:rPr b="0" i="1" lang="en-US" sz="20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6" name="" descr=""/>
            <p:cNvPicPr/>
            <p:nvPr/>
          </p:nvPicPr>
          <p:blipFill>
            <a:blip r:embed="rId1"/>
            <a:stretch/>
          </p:blipFill>
          <p:spPr>
            <a:xfrm>
              <a:off x="1712880" y="4138560"/>
              <a:ext cx="1590840" cy="1208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7" name=""/>
            <p:cNvSpPr/>
            <p:nvPr/>
          </p:nvSpPr>
          <p:spPr>
            <a:xfrm>
              <a:off x="2955960" y="5313240"/>
              <a:ext cx="322200" cy="1800"/>
            </a:xfrm>
            <a:prstGeom prst="line">
              <a:avLst/>
            </a:prstGeom>
            <a:ln w="284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2408040" y="1954080"/>
              <a:ext cx="3117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FITC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9" name="" descr=""/>
            <p:cNvPicPr/>
            <p:nvPr/>
          </p:nvPicPr>
          <p:blipFill>
            <a:blip r:embed="rId2"/>
            <a:stretch/>
          </p:blipFill>
          <p:spPr>
            <a:xfrm>
              <a:off x="3390840" y="4140360"/>
              <a:ext cx="1590840" cy="1209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0" name="" descr=""/>
            <p:cNvPicPr/>
            <p:nvPr/>
          </p:nvPicPr>
          <p:blipFill>
            <a:blip r:embed="rId3"/>
            <a:stretch/>
          </p:blipFill>
          <p:spPr>
            <a:xfrm>
              <a:off x="1712880" y="2133720"/>
              <a:ext cx="1590840" cy="1209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" descr=""/>
            <p:cNvPicPr/>
            <p:nvPr/>
          </p:nvPicPr>
          <p:blipFill>
            <a:blip r:embed="rId4"/>
            <a:stretch/>
          </p:blipFill>
          <p:spPr>
            <a:xfrm>
              <a:off x="3390840" y="2136600"/>
              <a:ext cx="1590840" cy="1208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2" name=""/>
            <p:cNvSpPr/>
            <p:nvPr/>
          </p:nvSpPr>
          <p:spPr>
            <a:xfrm>
              <a:off x="4629240" y="5313240"/>
              <a:ext cx="322200" cy="1800"/>
            </a:xfrm>
            <a:prstGeom prst="line">
              <a:avLst/>
            </a:prstGeom>
            <a:ln w="284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2952720" y="3305160"/>
              <a:ext cx="324000" cy="1440"/>
            </a:xfrm>
            <a:prstGeom prst="line">
              <a:avLst/>
            </a:prstGeom>
            <a:ln w="284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4626000" y="3305160"/>
              <a:ext cx="324000" cy="1440"/>
            </a:xfrm>
            <a:prstGeom prst="line">
              <a:avLst/>
            </a:prstGeom>
            <a:ln w="284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3817800" y="1954080"/>
              <a:ext cx="8067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FITC + DAPI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2480760" y="1666800"/>
              <a:ext cx="9104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100" spc="-1" strike="noStrike">
                  <a:solidFill>
                    <a:srgbClr val="000000"/>
                  </a:solidFill>
                  <a:latin typeface="Arial"/>
                </a:rPr>
                <a:t>Mesonephros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3424320" y="1666800"/>
              <a:ext cx="5554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male 50 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4014720" y="1668600"/>
              <a:ext cx="2491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100" spc="-1" strike="noStrike">
                  <a:solidFill>
                    <a:srgbClr val="000000"/>
                  </a:solidFill>
                  <a:latin typeface="Arial"/>
                </a:rPr>
                <a:t>d</a:t>
              </a:r>
              <a:r>
                <a:rPr b="1" i="1" lang="fr-FR" sz="1100" spc="-1" strike="noStrike">
                  <a:solidFill>
                    <a:srgbClr val="000000"/>
                  </a:solidFill>
                  <a:latin typeface="Arial"/>
                </a:rPr>
                <a:t>pc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2113200" y="3778200"/>
              <a:ext cx="4838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100" spc="-1" strike="noStrike">
                  <a:solidFill>
                    <a:srgbClr val="000000"/>
                  </a:solidFill>
                  <a:latin typeface="Arial"/>
                </a:rPr>
                <a:t>Female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2635560" y="3778200"/>
              <a:ext cx="4197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100" spc="-1" strike="noStrike">
                  <a:solidFill>
                    <a:srgbClr val="000000"/>
                  </a:solidFill>
                  <a:latin typeface="Arial"/>
                </a:rPr>
                <a:t>gonad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2385360" y="3946680"/>
              <a:ext cx="2811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50 d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2664000" y="3948120"/>
              <a:ext cx="1638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000000"/>
                  </a:solidFill>
                  <a:latin typeface="Arial"/>
                </a:rPr>
                <a:t>pc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3778920" y="3782880"/>
              <a:ext cx="3528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Male 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4131000" y="3782880"/>
              <a:ext cx="4197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100" spc="-1" strike="noStrike">
                  <a:solidFill>
                    <a:srgbClr val="000000"/>
                  </a:solidFill>
                  <a:latin typeface="Arial"/>
                </a:rPr>
                <a:t>gonad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3964320" y="3952800"/>
              <a:ext cx="1958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50 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4160880" y="3952800"/>
              <a:ext cx="860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d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4246560" y="3954600"/>
              <a:ext cx="1638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000000"/>
                  </a:solidFill>
                  <a:latin typeface="Arial"/>
                </a:rPr>
                <a:t>pc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1757160" y="2671920"/>
              <a:ext cx="320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ffff"/>
                  </a:solidFill>
                  <a:latin typeface="Arial"/>
                </a:rPr>
                <a:t>c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2211480" y="2995560"/>
              <a:ext cx="293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ffff"/>
                  </a:solidFill>
                  <a:latin typeface="Arial"/>
                </a:rPr>
                <a:t>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2516400" y="2604960"/>
              <a:ext cx="371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ffffff"/>
                  </a:solidFill>
                  <a:latin typeface="Arial"/>
                </a:rPr>
                <a:t>m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3427560" y="4586400"/>
              <a:ext cx="293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ffff"/>
                  </a:solidFill>
                  <a:latin typeface="Arial"/>
                </a:rPr>
                <a:t>t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3591000" y="4143240"/>
              <a:ext cx="412560" cy="1190880"/>
            </a:xfrm>
            <a:custGeom>
              <a:avLst/>
              <a:gdLst/>
              <a:ahLst/>
              <a:rect l="l" t="t" r="r" b="b"/>
              <a:pathLst>
                <a:path w="260" h="750">
                  <a:moveTo>
                    <a:pt x="38" y="750"/>
                  </a:moveTo>
                  <a:cubicBezTo>
                    <a:pt x="25" y="728"/>
                    <a:pt x="12" y="707"/>
                    <a:pt x="6" y="672"/>
                  </a:cubicBezTo>
                  <a:cubicBezTo>
                    <a:pt x="0" y="637"/>
                    <a:pt x="0" y="585"/>
                    <a:pt x="4" y="540"/>
                  </a:cubicBezTo>
                  <a:cubicBezTo>
                    <a:pt x="8" y="495"/>
                    <a:pt x="26" y="440"/>
                    <a:pt x="30" y="404"/>
                  </a:cubicBezTo>
                  <a:cubicBezTo>
                    <a:pt x="34" y="368"/>
                    <a:pt x="20" y="358"/>
                    <a:pt x="30" y="324"/>
                  </a:cubicBezTo>
                  <a:cubicBezTo>
                    <a:pt x="40" y="290"/>
                    <a:pt x="54" y="252"/>
                    <a:pt x="92" y="198"/>
                  </a:cubicBezTo>
                  <a:cubicBezTo>
                    <a:pt x="130" y="144"/>
                    <a:pt x="232" y="33"/>
                    <a:pt x="260" y="0"/>
                  </a:cubicBezTo>
                </a:path>
              </a:pathLst>
            </a:custGeom>
            <a:noFill/>
            <a:ln cap="rnd" w="9360">
              <a:solidFill>
                <a:srgbClr val="ffffff"/>
              </a:solidFill>
              <a:custDash>
                <a:ds d="100000" sp="1000"/>
              </a:custDash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9-12T11:51:43Z</dcterms:created>
  <dc:creator>DSDG</dc:creator>
  <dc:description/>
  <dc:language>en-US</dc:language>
  <cp:lastModifiedBy>Eric Pailhoux</cp:lastModifiedBy>
  <dcterms:modified xsi:type="dcterms:W3CDTF">2008-03-12T16:14:41Z</dcterms:modified>
  <cp:revision>7</cp:revision>
  <dc:subject/>
  <dc:title>Diapositive 1</dc:title>
</cp:coreProperties>
</file>